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DC45F6-CCD7-8CF3-8699-582E56E87C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9EF4BF-E4A2-A6D9-5774-AD32740928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5AC414-299B-55E0-7C16-4E0F895F7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2D2AB5-78B5-7FA4-3676-DBC572396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D22595-5DD8-54EA-BA06-4078DA2B7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596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7DD64A-DC6D-1BC2-2864-609884312C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F4425B-98EC-C807-8A59-DE325473E8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BEE3C4-89E7-8EBA-864D-746AEADBC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F6133A-9A4C-634D-37A4-CD4EE4DBDE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4610A8-9D7E-E55B-AEDD-388CD2E22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480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8F1A7EF-9785-9307-F714-D3D9EC652D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69DD31-1732-3A4A-2B7F-67A65A16E9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BE55D7-30C4-C3A7-783F-B83B950F1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4433B9-F4E0-6BE7-B1ED-4EAF6DA23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A50E25-8F34-4FA3-3EF7-EEDA0832A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274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44EC80-58B8-3041-DF50-AF97FE7CFC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8FF94B-4038-7D95-A7CF-6C23EF1AA5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0767B8-51B9-102A-1657-B648779AB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497176-40F5-37FF-81DA-103CDB569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466C4F-7A50-770F-8002-96A8EE1C9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404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59A512-CABE-435B-E667-8BFAFBDB41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12A215-71AB-44D1-BE4B-A0240478EA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E412D4-2D54-E478-303E-859E6372A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C71439-089A-BDF1-1883-8B4A703BC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B93B97-ED5F-25D3-8C34-70DB09553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794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74C25B-3BE1-ED4C-4EBF-A33285B928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2CA24C-E4E3-201E-FDD9-DE01D2279A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801619-F9E3-30FD-A33C-9A4AAE89EF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DC189A-099B-A4B8-4392-9006B4B7C7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8A46B7-2D51-F676-E97D-69595B186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451A1A-F913-BB23-E4B1-7EE6DC392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196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7D81CE-579B-6858-2354-BB4702BCF3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4C5879-1B7E-0008-B31A-A343924B32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F36802-54DB-B7F5-788E-BF4DAF616D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68FB8F4-5D81-5796-DCD2-4AA2A624D1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CE54CA-CECA-E83C-B36F-C594A2E034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860444-B1F0-A2B0-4F84-71D58346CF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66F2DA-D403-207D-4032-172FFDED3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C96F6ED-34E3-7125-DB97-5120F911F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1126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B332FE-2354-3A77-DAD4-3BF84CC72E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240B7B6-8628-E17A-1122-73F3B21A2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7F7BB60-F5BC-22C8-00AE-83B3CDBDB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C0E006-09C8-2AC9-5C66-1FD75BC66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891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B9A9EB2-C857-9834-D5A8-92A8E1E36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9F2086-8BEE-AF4E-EAC5-C291352FB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E52DA7-BA9B-AE67-B549-D93484C4F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8505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A57C0D-CE13-FDA6-37E3-0A5AFFB3D3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BC96E9-4270-C6DC-D1A6-01571D7A28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5D0246-B450-A957-5F0B-1EA4B0C019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C3F16C-FE92-3B15-8782-A53E0389C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C021CD-F6E2-9BD9-8207-28757DE372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BED317-E959-38CB-D849-5B5A4D798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305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FAD9B8-C1DB-470A-B899-FF76CE732F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6756F1-B748-9F88-697F-B4F265AD10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2F8D76-719A-F2ED-50D9-79DE03FCF9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A69272-478E-E8AF-CF79-E554AF161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45293F-B4F5-E310-ED06-E765CA37E8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DC155C-20E6-0E2B-0117-CA648F06B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1493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B0BC6E1-C22B-F730-DB40-2BD7802B09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3D383D-FFCE-C48D-9D12-DD19D26FE0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65238A-484F-CFDF-9153-E7E4FCA52C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8C1062-1BE9-D544-8ED9-FAA926E04422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F7634F-FEB6-1C0B-F615-60A5C244D0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E023FA-6D34-97FF-73BF-2E7BC30014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B9209-45B5-4545-9FA9-4D3EAA7ED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722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hart, line chart&#10;&#10;Description automatically generated">
            <a:extLst>
              <a:ext uri="{FF2B5EF4-FFF2-40B4-BE49-F238E27FC236}">
                <a16:creationId xmlns:a16="http://schemas.microsoft.com/office/drawing/2014/main" id="{D2A1D957-AE51-EF18-A346-5BA13A1927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5363" y="1947407"/>
            <a:ext cx="3657600" cy="2438400"/>
          </a:xfrm>
          <a:prstGeom prst="rect">
            <a:avLst/>
          </a:prstGeom>
        </p:spPr>
      </p:pic>
      <p:pic>
        <p:nvPicPr>
          <p:cNvPr id="5" name="Picture 4" descr="Chart, line chart&#10;&#10;Description automatically generated">
            <a:extLst>
              <a:ext uri="{FF2B5EF4-FFF2-40B4-BE49-F238E27FC236}">
                <a16:creationId xmlns:a16="http://schemas.microsoft.com/office/drawing/2014/main" id="{5A2D3B65-EA84-0760-66DF-B5E7AF18AB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82963" y="1947407"/>
            <a:ext cx="3657600" cy="2438400"/>
          </a:xfrm>
          <a:prstGeom prst="rect">
            <a:avLst/>
          </a:prstGeom>
        </p:spPr>
      </p:pic>
      <p:pic>
        <p:nvPicPr>
          <p:cNvPr id="6" name="Picture 5" descr="Chart, line chart&#10;&#10;Description automatically generated">
            <a:extLst>
              <a:ext uri="{FF2B5EF4-FFF2-40B4-BE49-F238E27FC236}">
                <a16:creationId xmlns:a16="http://schemas.microsoft.com/office/drawing/2014/main" id="{ADC4944D-773D-C294-733A-F6514C50FA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40563" y="1947407"/>
            <a:ext cx="3657600" cy="24384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D6B750A-34A9-20FE-E107-B3B3DBCB74BD}"/>
              </a:ext>
            </a:extLst>
          </p:cNvPr>
          <p:cNvSpPr txBox="1"/>
          <p:nvPr/>
        </p:nvSpPr>
        <p:spPr>
          <a:xfrm>
            <a:off x="526774" y="4784271"/>
            <a:ext cx="1095045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effectLst/>
                <a:latin typeface="Helvetica" pitchFamily="2" charset="0"/>
              </a:rPr>
              <a:t>Relative abundance of microbiome at the family level. Broilers were fed control or mycotoxin (FUM 3 mg/Kg diet + DON 4 mg/Kg diet). All birds received 1x 10</a:t>
            </a:r>
            <a:r>
              <a:rPr lang="en-US" baseline="30000" dirty="0">
                <a:effectLst/>
                <a:latin typeface="Helvetica" pitchFamily="2" charset="0"/>
              </a:rPr>
              <a:t>8</a:t>
            </a:r>
            <a:r>
              <a:rPr lang="en-US" dirty="0">
                <a:effectLst/>
                <a:latin typeface="Helvetica" pitchFamily="2" charset="0"/>
              </a:rPr>
              <a:t> CFU/bird of C. perfringens on d 19 and 20. Cecal digesta was analyzed for relative abundance of microbiome using 16S rRNA</a:t>
            </a:r>
          </a:p>
          <a:p>
            <a:r>
              <a:rPr lang="en-US" dirty="0">
                <a:effectLst/>
                <a:latin typeface="Helvetica" pitchFamily="2" charset="0"/>
              </a:rPr>
              <a:t>sequencing at 1, 7, and 14 days post-infection. Asterisk denotes significant difference (*, P &lt; 0.05).</a:t>
            </a:r>
          </a:p>
          <a:p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2A3E0FD-FE01-DB8E-A548-805296667810}"/>
              </a:ext>
            </a:extLst>
          </p:cNvPr>
          <p:cNvSpPr txBox="1"/>
          <p:nvPr/>
        </p:nvSpPr>
        <p:spPr>
          <a:xfrm>
            <a:off x="1530626" y="596401"/>
            <a:ext cx="87166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Helvetica" pitchFamily="2" charset="0"/>
              </a:rPr>
              <a:t>Effect of Subclinical doses of FUM and DON On Bacterial Genus Level </a:t>
            </a:r>
            <a:endParaRPr lang="en-US" dirty="0">
              <a:latin typeface="Helvetica" pitchFamily="2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414402C-98DA-2903-533F-F9BCDBB490B7}"/>
              </a:ext>
            </a:extLst>
          </p:cNvPr>
          <p:cNvSpPr txBox="1"/>
          <p:nvPr/>
        </p:nvSpPr>
        <p:spPr>
          <a:xfrm>
            <a:off x="3190461" y="2355574"/>
            <a:ext cx="417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0CA5928-EF7D-70D0-1049-BB90C49C0B3E}"/>
              </a:ext>
            </a:extLst>
          </p:cNvPr>
          <p:cNvSpPr txBox="1"/>
          <p:nvPr/>
        </p:nvSpPr>
        <p:spPr>
          <a:xfrm>
            <a:off x="6811617" y="2355574"/>
            <a:ext cx="417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8AA2A6A-8FD5-9A6A-EADE-1DEBCB2C04A2}"/>
              </a:ext>
            </a:extLst>
          </p:cNvPr>
          <p:cNvSpPr txBox="1"/>
          <p:nvPr/>
        </p:nvSpPr>
        <p:spPr>
          <a:xfrm>
            <a:off x="10469217" y="2355574"/>
            <a:ext cx="417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709694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95</Words>
  <Application>Microsoft Macintosh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n, Revathi - ARS</dc:creator>
  <cp:lastModifiedBy>Shan, Revathi - ARS</cp:lastModifiedBy>
  <cp:revision>1</cp:revision>
  <dcterms:created xsi:type="dcterms:W3CDTF">2023-03-17T18:55:01Z</dcterms:created>
  <dcterms:modified xsi:type="dcterms:W3CDTF">2023-03-17T19:20:23Z</dcterms:modified>
</cp:coreProperties>
</file>